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29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194" autoAdjust="0"/>
  </p:normalViewPr>
  <p:slideViewPr>
    <p:cSldViewPr snapToGrid="0" snapToObjects="1" showGuides="1">
      <p:cViewPr>
        <p:scale>
          <a:sx n="99" d="100"/>
          <a:sy n="99" d="100"/>
        </p:scale>
        <p:origin x="-1304" y="-80"/>
      </p:cViewPr>
      <p:guideLst>
        <p:guide orient="horz" pos="2880"/>
        <p:guide pos="221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88" d="100"/>
        <a:sy n="188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D2590C-021C-CE47-85CA-006D369F7FA3}" type="datetimeFigureOut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6C6187-154A-2844-B936-CEEB402319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8598322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3DAC3B-6EC8-7C44-AD8C-223E71AC9B48}" type="datetimeFigureOut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88E33F-A977-B94E-A196-A6A0594E4A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1773725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0CE65-6514-CB47-B134-E07529D2852D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285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CCFB-237F-2845-B5F1-792DD2EE8020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8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5E04B-180E-784E-A5DE-EA09220353E4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1211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B54F0-669A-3543-B66E-ADD1AF86AD5C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169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0DA3A-1064-7A4E-AB21-EA2FD47FBD9D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845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919B-F053-F040-A11E-DAA71844A73C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6957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71FAB-435B-E346-A109-1F37E583C929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5558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E142-966D-F847-95C7-C37FD305D179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2332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34BBD-1CF7-7647-A97E-F17DD8868C4C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54680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13D04-EA93-0944-B6C8-DB795AEE3BA8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3065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1CAF-C6CB-0B4E-953F-C4B3391DEBEE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0982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37851D-2A90-FA4D-ACF9-CC0160D00ACE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7501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図 69" descr="#8_n.bmp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37" t="17209" r="28534" b="11170"/>
          <a:stretch/>
        </p:blipFill>
        <p:spPr>
          <a:xfrm>
            <a:off x="1686417" y="5134186"/>
            <a:ext cx="1537260" cy="1450483"/>
          </a:xfrm>
          <a:prstGeom prst="rect">
            <a:avLst/>
          </a:prstGeom>
        </p:spPr>
      </p:pic>
      <p:pic>
        <p:nvPicPr>
          <p:cNvPr id="6" name="図 5" descr="#8_y.bmp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79" t="12166" r="31370" b="7642"/>
          <a:stretch/>
        </p:blipFill>
        <p:spPr>
          <a:xfrm>
            <a:off x="1693281" y="6542511"/>
            <a:ext cx="1457305" cy="1627595"/>
          </a:xfrm>
          <a:prstGeom prst="rect">
            <a:avLst/>
          </a:prstGeom>
        </p:spPr>
      </p:pic>
      <p:pic>
        <p:nvPicPr>
          <p:cNvPr id="7" name="図 6" descr="#23_n.bmp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70" t="17586" r="23265" b="2661"/>
          <a:stretch/>
        </p:blipFill>
        <p:spPr>
          <a:xfrm>
            <a:off x="3284551" y="5131354"/>
            <a:ext cx="1651611" cy="1636546"/>
          </a:xfrm>
          <a:prstGeom prst="rect">
            <a:avLst/>
          </a:prstGeom>
        </p:spPr>
      </p:pic>
      <p:pic>
        <p:nvPicPr>
          <p:cNvPr id="8" name="図 7" descr="#23_y.bmp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73" t="12355" r="26562" b="5157"/>
          <a:stretch/>
        </p:blipFill>
        <p:spPr>
          <a:xfrm>
            <a:off x="3202186" y="6537902"/>
            <a:ext cx="1651611" cy="1692644"/>
          </a:xfrm>
          <a:prstGeom prst="rect">
            <a:avLst/>
          </a:prstGeom>
        </p:spPr>
      </p:pic>
      <p:pic>
        <p:nvPicPr>
          <p:cNvPr id="9" name="図 8" descr="#35_n.bmp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96" t="11791" r="27473" b="6704"/>
          <a:stretch/>
        </p:blipFill>
        <p:spPr>
          <a:xfrm>
            <a:off x="4809135" y="5006044"/>
            <a:ext cx="1582215" cy="1672483"/>
          </a:xfrm>
          <a:prstGeom prst="rect">
            <a:avLst/>
          </a:prstGeom>
        </p:spPr>
      </p:pic>
      <p:pic>
        <p:nvPicPr>
          <p:cNvPr id="10" name="図 9" descr="#35_y.bmp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50" t="20218" r="27135" b="10114"/>
          <a:stretch/>
        </p:blipFill>
        <p:spPr>
          <a:xfrm>
            <a:off x="4837566" y="6688903"/>
            <a:ext cx="1554458" cy="1429591"/>
          </a:xfrm>
          <a:prstGeom prst="rect">
            <a:avLst/>
          </a:prstGeom>
        </p:spPr>
      </p:pic>
      <p:grpSp>
        <p:nvGrpSpPr>
          <p:cNvPr id="20" name="図形グループ 19"/>
          <p:cNvGrpSpPr/>
          <p:nvPr/>
        </p:nvGrpSpPr>
        <p:grpSpPr>
          <a:xfrm>
            <a:off x="1776557" y="5202226"/>
            <a:ext cx="1374029" cy="1353253"/>
            <a:chOff x="3740412" y="527822"/>
            <a:chExt cx="1374029" cy="1353253"/>
          </a:xfrm>
        </p:grpSpPr>
        <p:sp>
          <p:nvSpPr>
            <p:cNvPr id="11" name="正方形/長方形 10"/>
            <p:cNvSpPr/>
            <p:nvPr/>
          </p:nvSpPr>
          <p:spPr>
            <a:xfrm>
              <a:off x="3740412" y="527822"/>
              <a:ext cx="1374029" cy="13532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2" name="正方形/長方形 11"/>
            <p:cNvSpPr/>
            <p:nvPr/>
          </p:nvSpPr>
          <p:spPr>
            <a:xfrm>
              <a:off x="4244117" y="529201"/>
              <a:ext cx="361441" cy="2266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" name="正方形/長方形 12"/>
            <p:cNvSpPr/>
            <p:nvPr/>
          </p:nvSpPr>
          <p:spPr>
            <a:xfrm>
              <a:off x="4029818" y="529201"/>
              <a:ext cx="798817" cy="480631"/>
            </a:xfrm>
            <a:prstGeom prst="rect">
              <a:avLst/>
            </a:prstGeom>
            <a:noFill/>
            <a:ln>
              <a:solidFill>
                <a:srgbClr val="000000"/>
              </a:solidFill>
              <a:prstDash val="sys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4" name="Group 44"/>
          <p:cNvGrpSpPr>
            <a:grpSpLocks noChangeAspect="1"/>
          </p:cNvGrpSpPr>
          <p:nvPr/>
        </p:nvGrpSpPr>
        <p:grpSpPr>
          <a:xfrm rot="10800000">
            <a:off x="2380874" y="6726815"/>
            <a:ext cx="171035" cy="215999"/>
            <a:chOff x="3920667" y="1993576"/>
            <a:chExt cx="588191" cy="742822"/>
          </a:xfrm>
        </p:grpSpPr>
        <p:cxnSp>
          <p:nvCxnSpPr>
            <p:cNvPr id="15" name="Curved Connector 45"/>
            <p:cNvCxnSpPr/>
            <p:nvPr/>
          </p:nvCxnSpPr>
          <p:spPr>
            <a:xfrm rot="16200000" flipH="1">
              <a:off x="4192887" y="2571002"/>
              <a:ext cx="196397" cy="134396"/>
            </a:xfrm>
            <a:prstGeom prst="curvedConnector3">
              <a:avLst>
                <a:gd name="adj1" fmla="val 50000"/>
              </a:avLst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Oval 46"/>
            <p:cNvSpPr/>
            <p:nvPr/>
          </p:nvSpPr>
          <p:spPr>
            <a:xfrm rot="10800000">
              <a:off x="4175780" y="1993576"/>
              <a:ext cx="98525" cy="198189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  <p:sp>
          <p:nvSpPr>
            <p:cNvPr id="17" name="Oval 47"/>
            <p:cNvSpPr/>
            <p:nvPr/>
          </p:nvSpPr>
          <p:spPr>
            <a:xfrm>
              <a:off x="4032250" y="2171700"/>
              <a:ext cx="395974" cy="381000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  <p:sp>
          <p:nvSpPr>
            <p:cNvPr id="18" name="Oval 48"/>
            <p:cNvSpPr/>
            <p:nvPr/>
          </p:nvSpPr>
          <p:spPr>
            <a:xfrm rot="8102501">
              <a:off x="4244875" y="2019300"/>
              <a:ext cx="263983" cy="304800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  <p:sp>
          <p:nvSpPr>
            <p:cNvPr id="19" name="Oval 49"/>
            <p:cNvSpPr/>
            <p:nvPr/>
          </p:nvSpPr>
          <p:spPr>
            <a:xfrm rot="13888249">
              <a:off x="3941075" y="2019300"/>
              <a:ext cx="263983" cy="304800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</p:grpSp>
      <p:grpSp>
        <p:nvGrpSpPr>
          <p:cNvPr id="25" name="図形グループ 24"/>
          <p:cNvGrpSpPr/>
          <p:nvPr/>
        </p:nvGrpSpPr>
        <p:grpSpPr>
          <a:xfrm>
            <a:off x="3331936" y="5203605"/>
            <a:ext cx="1374029" cy="1353253"/>
            <a:chOff x="3740412" y="527822"/>
            <a:chExt cx="1374029" cy="1353253"/>
          </a:xfrm>
        </p:grpSpPr>
        <p:sp>
          <p:nvSpPr>
            <p:cNvPr id="26" name="正方形/長方形 25"/>
            <p:cNvSpPr/>
            <p:nvPr/>
          </p:nvSpPr>
          <p:spPr>
            <a:xfrm>
              <a:off x="3740412" y="527822"/>
              <a:ext cx="1374029" cy="13532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" name="正方形/長方形 26"/>
            <p:cNvSpPr/>
            <p:nvPr/>
          </p:nvSpPr>
          <p:spPr>
            <a:xfrm>
              <a:off x="4244117" y="529201"/>
              <a:ext cx="361441" cy="2266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8" name="正方形/長方形 27"/>
            <p:cNvSpPr/>
            <p:nvPr/>
          </p:nvSpPr>
          <p:spPr>
            <a:xfrm>
              <a:off x="4029818" y="529201"/>
              <a:ext cx="798817" cy="480631"/>
            </a:xfrm>
            <a:prstGeom prst="rect">
              <a:avLst/>
            </a:prstGeom>
            <a:noFill/>
            <a:ln>
              <a:solidFill>
                <a:srgbClr val="000000"/>
              </a:solidFill>
              <a:prstDash val="sys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9" name="図形グループ 28"/>
          <p:cNvGrpSpPr/>
          <p:nvPr/>
        </p:nvGrpSpPr>
        <p:grpSpPr>
          <a:xfrm>
            <a:off x="4888777" y="5202226"/>
            <a:ext cx="1374029" cy="1353253"/>
            <a:chOff x="3740412" y="527822"/>
            <a:chExt cx="1374029" cy="1353253"/>
          </a:xfrm>
        </p:grpSpPr>
        <p:sp>
          <p:nvSpPr>
            <p:cNvPr id="30" name="正方形/長方形 29"/>
            <p:cNvSpPr/>
            <p:nvPr/>
          </p:nvSpPr>
          <p:spPr>
            <a:xfrm>
              <a:off x="3740412" y="527822"/>
              <a:ext cx="1374029" cy="13532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1" name="正方形/長方形 30"/>
            <p:cNvSpPr/>
            <p:nvPr/>
          </p:nvSpPr>
          <p:spPr>
            <a:xfrm>
              <a:off x="4244117" y="529201"/>
              <a:ext cx="361441" cy="2266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2" name="正方形/長方形 31"/>
            <p:cNvSpPr/>
            <p:nvPr/>
          </p:nvSpPr>
          <p:spPr>
            <a:xfrm>
              <a:off x="4029818" y="529201"/>
              <a:ext cx="798817" cy="480631"/>
            </a:xfrm>
            <a:prstGeom prst="rect">
              <a:avLst/>
            </a:prstGeom>
            <a:noFill/>
            <a:ln>
              <a:solidFill>
                <a:srgbClr val="000000"/>
              </a:solidFill>
              <a:prstDash val="sys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33" name="図形グループ 32"/>
          <p:cNvGrpSpPr/>
          <p:nvPr/>
        </p:nvGrpSpPr>
        <p:grpSpPr>
          <a:xfrm>
            <a:off x="1776557" y="6717594"/>
            <a:ext cx="1374029" cy="1353253"/>
            <a:chOff x="3740412" y="527822"/>
            <a:chExt cx="1374029" cy="1353253"/>
          </a:xfrm>
        </p:grpSpPr>
        <p:sp>
          <p:nvSpPr>
            <p:cNvPr id="34" name="正方形/長方形 33"/>
            <p:cNvSpPr/>
            <p:nvPr/>
          </p:nvSpPr>
          <p:spPr>
            <a:xfrm>
              <a:off x="3740412" y="527822"/>
              <a:ext cx="1374029" cy="13532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" name="正方形/長方形 34"/>
            <p:cNvSpPr/>
            <p:nvPr/>
          </p:nvSpPr>
          <p:spPr>
            <a:xfrm>
              <a:off x="4244117" y="529201"/>
              <a:ext cx="361441" cy="2266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" name="正方形/長方形 35"/>
            <p:cNvSpPr/>
            <p:nvPr/>
          </p:nvSpPr>
          <p:spPr>
            <a:xfrm>
              <a:off x="4029818" y="529201"/>
              <a:ext cx="798817" cy="480631"/>
            </a:xfrm>
            <a:prstGeom prst="rect">
              <a:avLst/>
            </a:prstGeom>
            <a:noFill/>
            <a:ln>
              <a:solidFill>
                <a:srgbClr val="000000"/>
              </a:solidFill>
              <a:prstDash val="sys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37" name="図形グループ 36"/>
          <p:cNvGrpSpPr/>
          <p:nvPr/>
        </p:nvGrpSpPr>
        <p:grpSpPr>
          <a:xfrm>
            <a:off x="3331936" y="6724988"/>
            <a:ext cx="1374029" cy="1353253"/>
            <a:chOff x="3740412" y="527822"/>
            <a:chExt cx="1374029" cy="1353253"/>
          </a:xfrm>
        </p:grpSpPr>
        <p:sp>
          <p:nvSpPr>
            <p:cNvPr id="38" name="正方形/長方形 37"/>
            <p:cNvSpPr/>
            <p:nvPr/>
          </p:nvSpPr>
          <p:spPr>
            <a:xfrm>
              <a:off x="3740412" y="527822"/>
              <a:ext cx="1374029" cy="13532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" name="正方形/長方形 38"/>
            <p:cNvSpPr/>
            <p:nvPr/>
          </p:nvSpPr>
          <p:spPr>
            <a:xfrm>
              <a:off x="4244117" y="529201"/>
              <a:ext cx="361441" cy="2266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" name="正方形/長方形 39"/>
            <p:cNvSpPr/>
            <p:nvPr/>
          </p:nvSpPr>
          <p:spPr>
            <a:xfrm>
              <a:off x="4029818" y="529201"/>
              <a:ext cx="798817" cy="480631"/>
            </a:xfrm>
            <a:prstGeom prst="rect">
              <a:avLst/>
            </a:prstGeom>
            <a:noFill/>
            <a:ln>
              <a:solidFill>
                <a:srgbClr val="000000"/>
              </a:solidFill>
              <a:prstDash val="sys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41" name="図形グループ 40"/>
          <p:cNvGrpSpPr/>
          <p:nvPr/>
        </p:nvGrpSpPr>
        <p:grpSpPr>
          <a:xfrm>
            <a:off x="4888777" y="6726367"/>
            <a:ext cx="1374029" cy="1353253"/>
            <a:chOff x="3740412" y="527822"/>
            <a:chExt cx="1374029" cy="1353253"/>
          </a:xfrm>
        </p:grpSpPr>
        <p:sp>
          <p:nvSpPr>
            <p:cNvPr id="42" name="正方形/長方形 41"/>
            <p:cNvSpPr/>
            <p:nvPr/>
          </p:nvSpPr>
          <p:spPr>
            <a:xfrm>
              <a:off x="3740412" y="527822"/>
              <a:ext cx="1374029" cy="13532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" name="正方形/長方形 42"/>
            <p:cNvSpPr/>
            <p:nvPr/>
          </p:nvSpPr>
          <p:spPr>
            <a:xfrm>
              <a:off x="4244117" y="529201"/>
              <a:ext cx="361441" cy="2266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" name="正方形/長方形 43"/>
            <p:cNvSpPr/>
            <p:nvPr/>
          </p:nvSpPr>
          <p:spPr>
            <a:xfrm>
              <a:off x="4029818" y="529201"/>
              <a:ext cx="798817" cy="480631"/>
            </a:xfrm>
            <a:prstGeom prst="rect">
              <a:avLst/>
            </a:prstGeom>
            <a:noFill/>
            <a:ln>
              <a:solidFill>
                <a:srgbClr val="000000"/>
              </a:solidFill>
              <a:prstDash val="sys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45" name="Group 44"/>
          <p:cNvGrpSpPr>
            <a:grpSpLocks noChangeAspect="1"/>
          </p:cNvGrpSpPr>
          <p:nvPr/>
        </p:nvGrpSpPr>
        <p:grpSpPr>
          <a:xfrm rot="10800000">
            <a:off x="3935912" y="6726510"/>
            <a:ext cx="171035" cy="215999"/>
            <a:chOff x="3920667" y="1993576"/>
            <a:chExt cx="588191" cy="742822"/>
          </a:xfrm>
        </p:grpSpPr>
        <p:cxnSp>
          <p:nvCxnSpPr>
            <p:cNvPr id="46" name="Curved Connector 45"/>
            <p:cNvCxnSpPr/>
            <p:nvPr/>
          </p:nvCxnSpPr>
          <p:spPr>
            <a:xfrm rot="16200000" flipH="1">
              <a:off x="4192887" y="2571002"/>
              <a:ext cx="196397" cy="134396"/>
            </a:xfrm>
            <a:prstGeom prst="curvedConnector3">
              <a:avLst>
                <a:gd name="adj1" fmla="val 50000"/>
              </a:avLst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Oval 46"/>
            <p:cNvSpPr/>
            <p:nvPr/>
          </p:nvSpPr>
          <p:spPr>
            <a:xfrm rot="10800000">
              <a:off x="4175780" y="1993576"/>
              <a:ext cx="98525" cy="198189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  <p:sp>
          <p:nvSpPr>
            <p:cNvPr id="48" name="Oval 47"/>
            <p:cNvSpPr/>
            <p:nvPr/>
          </p:nvSpPr>
          <p:spPr>
            <a:xfrm>
              <a:off x="4032250" y="2171700"/>
              <a:ext cx="395974" cy="381000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  <p:sp>
          <p:nvSpPr>
            <p:cNvPr id="49" name="Oval 48"/>
            <p:cNvSpPr/>
            <p:nvPr/>
          </p:nvSpPr>
          <p:spPr>
            <a:xfrm rot="8102501">
              <a:off x="4244875" y="2019300"/>
              <a:ext cx="263983" cy="304800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  <p:sp>
          <p:nvSpPr>
            <p:cNvPr id="50" name="Oval 49"/>
            <p:cNvSpPr/>
            <p:nvPr/>
          </p:nvSpPr>
          <p:spPr>
            <a:xfrm rot="13888249">
              <a:off x="3941075" y="2019300"/>
              <a:ext cx="263983" cy="304800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</p:grpSp>
      <p:grpSp>
        <p:nvGrpSpPr>
          <p:cNvPr id="51" name="Group 44"/>
          <p:cNvGrpSpPr>
            <a:grpSpLocks noChangeAspect="1"/>
          </p:cNvGrpSpPr>
          <p:nvPr/>
        </p:nvGrpSpPr>
        <p:grpSpPr>
          <a:xfrm rot="10800000">
            <a:off x="5490187" y="6727746"/>
            <a:ext cx="171035" cy="215999"/>
            <a:chOff x="3920667" y="1993576"/>
            <a:chExt cx="588191" cy="742822"/>
          </a:xfrm>
        </p:grpSpPr>
        <p:cxnSp>
          <p:nvCxnSpPr>
            <p:cNvPr id="52" name="Curved Connector 45"/>
            <p:cNvCxnSpPr/>
            <p:nvPr/>
          </p:nvCxnSpPr>
          <p:spPr>
            <a:xfrm rot="16200000" flipH="1">
              <a:off x="4192887" y="2571002"/>
              <a:ext cx="196397" cy="134396"/>
            </a:xfrm>
            <a:prstGeom prst="curvedConnector3">
              <a:avLst>
                <a:gd name="adj1" fmla="val 50000"/>
              </a:avLst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Oval 46"/>
            <p:cNvSpPr/>
            <p:nvPr/>
          </p:nvSpPr>
          <p:spPr>
            <a:xfrm rot="10800000">
              <a:off x="4175780" y="1993576"/>
              <a:ext cx="98525" cy="198189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  <p:sp>
          <p:nvSpPr>
            <p:cNvPr id="54" name="Oval 47"/>
            <p:cNvSpPr/>
            <p:nvPr/>
          </p:nvSpPr>
          <p:spPr>
            <a:xfrm>
              <a:off x="4032250" y="2171700"/>
              <a:ext cx="395974" cy="381000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  <p:sp>
          <p:nvSpPr>
            <p:cNvPr id="55" name="Oval 48"/>
            <p:cNvSpPr/>
            <p:nvPr/>
          </p:nvSpPr>
          <p:spPr>
            <a:xfrm rot="8102501">
              <a:off x="4244875" y="2019300"/>
              <a:ext cx="263983" cy="304800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  <p:sp>
          <p:nvSpPr>
            <p:cNvPr id="56" name="Oval 49"/>
            <p:cNvSpPr/>
            <p:nvPr/>
          </p:nvSpPr>
          <p:spPr>
            <a:xfrm rot="13888249">
              <a:off x="3941075" y="2019300"/>
              <a:ext cx="263983" cy="304800"/>
            </a:xfrm>
            <a:prstGeom prst="ellipse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"/>
              </a:endParaRPr>
            </a:p>
          </p:txBody>
        </p:sp>
      </p:grpSp>
      <p:sp>
        <p:nvSpPr>
          <p:cNvPr id="57" name="TextBox 40"/>
          <p:cNvSpPr txBox="1"/>
          <p:nvPr/>
        </p:nvSpPr>
        <p:spPr>
          <a:xfrm>
            <a:off x="416897" y="5658403"/>
            <a:ext cx="1500297" cy="58477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600" b="1" dirty="0" smtClean="0">
                <a:latin typeface="Times"/>
                <a:cs typeface="Times"/>
              </a:rPr>
              <a:t>Aggressor</a:t>
            </a:r>
          </a:p>
          <a:p>
            <a:pPr algn="ctr"/>
            <a:r>
              <a:rPr lang="en-US" sz="1600" b="1" dirty="0" smtClean="0">
                <a:latin typeface="Times"/>
                <a:cs typeface="Times"/>
              </a:rPr>
              <a:t>(-)</a:t>
            </a:r>
          </a:p>
        </p:txBody>
      </p:sp>
      <p:sp>
        <p:nvSpPr>
          <p:cNvPr id="58" name="TextBox 40"/>
          <p:cNvSpPr txBox="1"/>
          <p:nvPr/>
        </p:nvSpPr>
        <p:spPr>
          <a:xfrm>
            <a:off x="1788966" y="4789521"/>
            <a:ext cx="136467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600" b="1" u="sng" dirty="0" smtClean="0">
                <a:latin typeface="Times"/>
                <a:cs typeface="Times"/>
              </a:rPr>
              <a:t>ND + Water</a:t>
            </a:r>
          </a:p>
        </p:txBody>
      </p:sp>
      <p:sp>
        <p:nvSpPr>
          <p:cNvPr id="59" name="TextBox 40"/>
          <p:cNvSpPr txBox="1"/>
          <p:nvPr/>
        </p:nvSpPr>
        <p:spPr>
          <a:xfrm>
            <a:off x="416897" y="7080774"/>
            <a:ext cx="1500297" cy="58477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600" b="1" dirty="0" smtClean="0">
                <a:latin typeface="Times"/>
                <a:cs typeface="Times"/>
              </a:rPr>
              <a:t>Aggressor</a:t>
            </a:r>
          </a:p>
          <a:p>
            <a:pPr algn="ctr"/>
            <a:r>
              <a:rPr lang="en-US" sz="1600" b="1" dirty="0" smtClean="0">
                <a:latin typeface="Times"/>
                <a:cs typeface="Times"/>
              </a:rPr>
              <a:t>(</a:t>
            </a:r>
            <a:r>
              <a:rPr lang="en-US" sz="1600" b="1" dirty="0">
                <a:latin typeface="Times"/>
                <a:cs typeface="Times"/>
              </a:rPr>
              <a:t>+</a:t>
            </a:r>
            <a:r>
              <a:rPr lang="en-US" sz="1600" b="1" dirty="0" smtClean="0">
                <a:latin typeface="Times"/>
                <a:cs typeface="Times"/>
              </a:rPr>
              <a:t>)</a:t>
            </a:r>
          </a:p>
        </p:txBody>
      </p:sp>
      <p:sp>
        <p:nvSpPr>
          <p:cNvPr id="60" name="TextBox 40"/>
          <p:cNvSpPr txBox="1"/>
          <p:nvPr/>
        </p:nvSpPr>
        <p:spPr>
          <a:xfrm>
            <a:off x="3315002" y="4789521"/>
            <a:ext cx="136467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600" b="1" u="sng" dirty="0" smtClean="0">
                <a:latin typeface="Times"/>
                <a:cs typeface="Times"/>
              </a:rPr>
              <a:t>D + Water</a:t>
            </a:r>
          </a:p>
        </p:txBody>
      </p:sp>
      <p:sp>
        <p:nvSpPr>
          <p:cNvPr id="61" name="TextBox 40"/>
          <p:cNvSpPr txBox="1"/>
          <p:nvPr/>
        </p:nvSpPr>
        <p:spPr>
          <a:xfrm>
            <a:off x="4882173" y="4789521"/>
            <a:ext cx="1364670" cy="3385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600" b="1" u="sng" dirty="0" smtClean="0">
                <a:latin typeface="Times"/>
                <a:cs typeface="Times"/>
              </a:rPr>
              <a:t>D + KS</a:t>
            </a: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659859" y="607926"/>
            <a:ext cx="851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"/>
                <a:cs typeface="Times"/>
              </a:rPr>
              <a:t>Fig. S1</a:t>
            </a:r>
            <a:endParaRPr kumimoji="1" lang="ja-JP" altLang="en-US" dirty="0">
              <a:latin typeface="Times"/>
              <a:cs typeface="Times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1150625" y="1159168"/>
            <a:ext cx="409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/>
                <a:cs typeface="Times"/>
              </a:rPr>
              <a:t>A</a:t>
            </a:r>
            <a:r>
              <a:rPr kumimoji="1" lang="en-US" altLang="ja-JP" b="1" dirty="0" smtClean="0">
                <a:latin typeface="Times"/>
                <a:cs typeface="Times"/>
              </a:rPr>
              <a:t>.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1115325" y="4376821"/>
            <a:ext cx="396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"/>
                <a:cs typeface="Times"/>
              </a:rPr>
              <a:t>B. 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76975" y="1559435"/>
            <a:ext cx="2870200" cy="2057400"/>
          </a:xfrm>
          <a:prstGeom prst="rect">
            <a:avLst/>
          </a:prstGeom>
        </p:spPr>
      </p:pic>
      <p:sp>
        <p:nvSpPr>
          <p:cNvPr id="65" name="テキスト ボックス 64"/>
          <p:cNvSpPr txBox="1"/>
          <p:nvPr/>
        </p:nvSpPr>
        <p:spPr>
          <a:xfrm rot="16200000">
            <a:off x="567128" y="2445373"/>
            <a:ext cx="20717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"/>
                <a:cs typeface="Times"/>
              </a:rPr>
              <a:t>Time spent in SI zone (s)</a:t>
            </a:r>
            <a:endParaRPr kumimoji="1" lang="ja-JP" altLang="en-US" sz="1400" b="1" dirty="0">
              <a:latin typeface="Times"/>
              <a:cs typeface="Times"/>
            </a:endParaRPr>
          </a:p>
        </p:txBody>
      </p:sp>
      <p:sp>
        <p:nvSpPr>
          <p:cNvPr id="66" name="TextBox 40"/>
          <p:cNvSpPr txBox="1"/>
          <p:nvPr/>
        </p:nvSpPr>
        <p:spPr>
          <a:xfrm>
            <a:off x="5309764" y="1292618"/>
            <a:ext cx="1236092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b="1" dirty="0" smtClean="0">
                <a:latin typeface="Times"/>
                <a:cs typeface="Times"/>
              </a:rPr>
              <a:t>Aggressor (-)</a:t>
            </a:r>
          </a:p>
        </p:txBody>
      </p:sp>
      <p:sp>
        <p:nvSpPr>
          <p:cNvPr id="67" name="TextBox 40"/>
          <p:cNvSpPr txBox="1"/>
          <p:nvPr/>
        </p:nvSpPr>
        <p:spPr>
          <a:xfrm>
            <a:off x="5330297" y="1528500"/>
            <a:ext cx="1236092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b="1" dirty="0" smtClean="0">
                <a:latin typeface="Times"/>
                <a:cs typeface="Times"/>
              </a:rPr>
              <a:t>Aggressor (</a:t>
            </a:r>
            <a:r>
              <a:rPr lang="en-US" sz="1200" b="1" dirty="0">
                <a:latin typeface="Times"/>
                <a:cs typeface="Times"/>
              </a:rPr>
              <a:t>+</a:t>
            </a:r>
            <a:r>
              <a:rPr lang="en-US" sz="1200" b="1" dirty="0" smtClean="0">
                <a:latin typeface="Times"/>
                <a:cs typeface="Times"/>
              </a:rPr>
              <a:t>)</a:t>
            </a: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2037110" y="2759232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4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2037110" y="245296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6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1947342" y="184043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1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2037110" y="306549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2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2126878" y="337176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2037110" y="214669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8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1947342" y="1534162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12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76" name="正方形/長方形 75"/>
          <p:cNvSpPr/>
          <p:nvPr/>
        </p:nvSpPr>
        <p:spPr>
          <a:xfrm>
            <a:off x="5190498" y="1403385"/>
            <a:ext cx="228143" cy="125115"/>
          </a:xfrm>
          <a:prstGeom prst="rect">
            <a:avLst/>
          </a:prstGeom>
          <a:solidFill>
            <a:schemeClr val="bg1">
              <a:lumMod val="75000"/>
            </a:schemeClr>
          </a:solidFill>
          <a:ln w="1905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77" name="正方形/長方形 76"/>
          <p:cNvSpPr/>
          <p:nvPr/>
        </p:nvSpPr>
        <p:spPr>
          <a:xfrm>
            <a:off x="5194992" y="1637839"/>
            <a:ext cx="228143" cy="12511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1313988" y="3638930"/>
            <a:ext cx="1153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"/>
                <a:cs typeface="Times"/>
              </a:rPr>
              <a:t>Defeat stress</a:t>
            </a:r>
            <a:endParaRPr kumimoji="1" lang="ja-JP" altLang="en-US" sz="1400" b="1" dirty="0">
              <a:latin typeface="Times"/>
              <a:cs typeface="Times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1313988" y="3972153"/>
            <a:ext cx="11871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"/>
                <a:cs typeface="Times"/>
              </a:rPr>
              <a:t>KS (1.0 g/kg)</a:t>
            </a:r>
            <a:endParaRPr kumimoji="1" lang="ja-JP" altLang="en-US" sz="1400" b="1" dirty="0">
              <a:latin typeface="Times"/>
              <a:cs typeface="Times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2702944" y="3570218"/>
            <a:ext cx="287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 smtClean="0">
                <a:latin typeface="Times"/>
                <a:cs typeface="Times"/>
              </a:rPr>
              <a:t>-</a:t>
            </a:r>
            <a:endParaRPr kumimoji="1" lang="ja-JP" altLang="en-US" sz="2400" b="1" dirty="0">
              <a:latin typeface="Times"/>
              <a:cs typeface="Times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2702944" y="3889547"/>
            <a:ext cx="287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 smtClean="0">
                <a:latin typeface="Times"/>
                <a:cs typeface="Times"/>
              </a:rPr>
              <a:t>-</a:t>
            </a:r>
            <a:endParaRPr kumimoji="1" lang="ja-JP" altLang="en-US" sz="2400" b="1" dirty="0">
              <a:latin typeface="Times"/>
              <a:cs typeface="Times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3661368" y="3889547"/>
            <a:ext cx="287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 smtClean="0">
                <a:latin typeface="Times"/>
                <a:cs typeface="Times"/>
              </a:rPr>
              <a:t>-</a:t>
            </a:r>
            <a:endParaRPr kumimoji="1" lang="ja-JP" altLang="en-US" sz="2400" b="1" dirty="0">
              <a:latin typeface="Times"/>
              <a:cs typeface="Times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3626566" y="3573613"/>
            <a:ext cx="3600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"/>
                <a:cs typeface="Times"/>
              </a:rPr>
              <a:t>+</a:t>
            </a:r>
            <a:endParaRPr kumimoji="1" lang="ja-JP" altLang="en-US" sz="2400" b="1" dirty="0">
              <a:latin typeface="Times"/>
              <a:cs typeface="Times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4596297" y="3573613"/>
            <a:ext cx="3600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"/>
                <a:cs typeface="Times"/>
              </a:rPr>
              <a:t>+</a:t>
            </a:r>
            <a:endParaRPr kumimoji="1" lang="ja-JP" altLang="en-US" sz="2400" b="1" dirty="0">
              <a:latin typeface="Times"/>
              <a:cs typeface="Times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4596297" y="3899707"/>
            <a:ext cx="3600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"/>
                <a:cs typeface="Times"/>
              </a:rPr>
              <a:t>+</a:t>
            </a:r>
            <a:endParaRPr kumimoji="1" lang="ja-JP" altLang="en-US" sz="2400" b="1" dirty="0">
              <a:latin typeface="Times"/>
              <a:cs typeface="Times"/>
            </a:endParaRPr>
          </a:p>
        </p:txBody>
      </p:sp>
      <p:sp>
        <p:nvSpPr>
          <p:cNvPr id="89" name="左大かっこ 88"/>
          <p:cNvSpPr/>
          <p:nvPr/>
        </p:nvSpPr>
        <p:spPr>
          <a:xfrm rot="5400000">
            <a:off x="2831196" y="1783438"/>
            <a:ext cx="49126" cy="363050"/>
          </a:xfrm>
          <a:prstGeom prst="leftBracket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"/>
              <a:cs typeface="Times"/>
            </a:endParaRPr>
          </a:p>
        </p:txBody>
      </p:sp>
      <p:sp>
        <p:nvSpPr>
          <p:cNvPr id="90" name="TextBox 40"/>
          <p:cNvSpPr txBox="1"/>
          <p:nvPr/>
        </p:nvSpPr>
        <p:spPr>
          <a:xfrm>
            <a:off x="2593189" y="1685503"/>
            <a:ext cx="523288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 smtClean="0">
                <a:latin typeface="Times"/>
                <a:cs typeface="Times"/>
              </a:rPr>
              <a:t>**</a:t>
            </a:r>
          </a:p>
        </p:txBody>
      </p:sp>
      <p:sp>
        <p:nvSpPr>
          <p:cNvPr id="91" name="左大かっこ 90"/>
          <p:cNvSpPr/>
          <p:nvPr/>
        </p:nvSpPr>
        <p:spPr>
          <a:xfrm rot="5400000">
            <a:off x="4744968" y="1810462"/>
            <a:ext cx="49126" cy="363050"/>
          </a:xfrm>
          <a:prstGeom prst="leftBracket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"/>
              <a:cs typeface="Times"/>
            </a:endParaRPr>
          </a:p>
        </p:txBody>
      </p:sp>
      <p:sp>
        <p:nvSpPr>
          <p:cNvPr id="92" name="TextBox 40"/>
          <p:cNvSpPr txBox="1"/>
          <p:nvPr/>
        </p:nvSpPr>
        <p:spPr>
          <a:xfrm>
            <a:off x="4506961" y="1712527"/>
            <a:ext cx="523288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 smtClean="0">
                <a:latin typeface="Times"/>
                <a:cs typeface="Times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9222969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5.20736E-6 1.9685E-6 C 0.00018 1.9685E-6 0.01354 0.00139 0.01475 0.00371 C 0.01632 0.00672 0.01753 0.01436 0.01753 0.01436 C 0.01614 0.04655 0.02291 0.05605 0.00261 0.05211 C -0.00034 0.04609 -0.00399 0.04354 -0.00676 0.03775 C -0.00902 0.02617 -0.01422 0.02084 -0.02169 0.01621 C -0.02533 0.00116 -0.02394 0.00903 -0.02568 -0.00718 C -0.02533 -0.02107 -0.02602 -0.0352 -0.02429 -0.04863 C -0.02411 -0.05118 -0.01526 -0.05442 -0.01214 -0.05581 C -0.01093 -0.05651 -0.00815 -0.05766 -0.00815 -0.05766 C -0.0019 -0.05697 0.00573 -0.05952 0.01076 -0.05396 C 0.01198 -0.0528 0.01215 -0.05025 0.01337 -0.04863 C 0.0158 -0.04585 0.02152 -0.04145 0.02152 -0.04145 C 0.02465 -0.02872 0.02256 -0.03381 0.0269 -0.02524 C 0.02707 -0.01992 0.03159 0.02756 0.02829 0.03775 C 0.02759 0.03937 0.02551 0.03891 0.0243 0.0396 C 0.02152 0.03821 0.01857 0.03775 0.01614 0.0359 C 0.01198 0.03242 0.01493 0.02802 0.00938 0.02686 C 0.00226 0.02524 -0.00503 0.02571 -0.01214 0.02524 C -0.01336 0.02524 -0.02463 0.0264 -0.02568 0.02872 C -0.02793 0.03265 -0.02967 0.04493 -0.02967 0.05026 " pathEditMode="relative" ptsTypes="ffffffffffffffffffffA">
                                      <p:cBhvr>
                                        <p:cTn id="6" dur="2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7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5.20736E-6 1.9685E-6 C 0.00018 1.9685E-6 0.01354 0.00139 0.01475 0.00371 C 0.01632 0.00672 0.01753 0.01436 0.01753 0.01436 C 0.01614 0.04655 0.02291 0.05605 0.00261 0.05211 C -0.00034 0.04609 -0.00399 0.04354 -0.00676 0.03775 C -0.00902 0.02617 -0.01422 0.02084 -0.02169 0.01621 C -0.02533 0.00116 -0.02394 0.00903 -0.02568 -0.00718 C -0.02533 -0.02107 -0.02602 -0.0352 -0.02429 -0.04863 C -0.02411 -0.05118 -0.01526 -0.05442 -0.01214 -0.05581 C -0.01093 -0.05651 -0.00815 -0.05766 -0.00815 -0.05766 C -0.0019 -0.05697 0.00573 -0.05952 0.01076 -0.05396 C 0.01198 -0.0528 0.01215 -0.05025 0.01337 -0.04863 C 0.0158 -0.04585 0.02152 -0.04145 0.02152 -0.04145 C 0.02465 -0.02872 0.02256 -0.03381 0.0269 -0.02524 C 0.02707 -0.01992 0.03159 0.02756 0.02829 0.03775 C 0.02759 0.03937 0.02551 0.03891 0.0243 0.0396 C 0.02152 0.03821 0.01857 0.03775 0.01614 0.0359 C 0.01198 0.03242 0.01493 0.02802 0.00938 0.02686 C 0.00226 0.02524 -0.00503 0.02571 -0.01214 0.02524 C -0.01336 0.02524 -0.02463 0.0264 -0.02568 0.02872 C -0.02793 0.03265 -0.02967 0.04493 -0.02967 0.05026 " pathEditMode="relative" ptsTypes="ffffffffffffffffffffA">
                                      <p:cBhvr>
                                        <p:cTn id="8" dur="2000" fill="hold"/>
                                        <p:tgtEl>
                                          <p:spTgt spid="4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9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5.20736E-6 1.9685E-6 C 0.00018 1.9685E-6 0.01354 0.00139 0.01475 0.00371 C 0.01632 0.00672 0.01753 0.01436 0.01753 0.01436 C 0.01614 0.04655 0.02291 0.05605 0.00261 0.05211 C -0.00034 0.04609 -0.00399 0.04354 -0.00676 0.03775 C -0.00902 0.02617 -0.01422 0.02084 -0.02169 0.01621 C -0.02533 0.00116 -0.02394 0.00903 -0.02568 -0.00718 C -0.02533 -0.02107 -0.02602 -0.0352 -0.02429 -0.04863 C -0.02411 -0.05118 -0.01526 -0.05442 -0.01214 -0.05581 C -0.01093 -0.05651 -0.00815 -0.05766 -0.00815 -0.05766 C -0.0019 -0.05697 0.00573 -0.05952 0.01076 -0.05396 C 0.01198 -0.0528 0.01215 -0.05025 0.01337 -0.04863 C 0.0158 -0.04585 0.02152 -0.04145 0.02152 -0.04145 C 0.02465 -0.02872 0.02256 -0.03381 0.0269 -0.02524 C 0.02707 -0.01992 0.03159 0.02756 0.02829 0.03775 C 0.02759 0.03937 0.02551 0.03891 0.0243 0.0396 C 0.02152 0.03821 0.01857 0.03775 0.01614 0.0359 C 0.01198 0.03242 0.01493 0.02802 0.00938 0.02686 C 0.00226 0.02524 -0.00503 0.02571 -0.01214 0.02524 C -0.01336 0.02524 -0.02463 0.0264 -0.02568 0.02872 C -0.02793 0.03265 -0.02967 0.04493 -0.02967 0.05026 " pathEditMode="relative" ptsTypes="ffffffffffffffffffffA">
                                      <p:cBhvr>
                                        <p:cTn id="10" dur="2000" fill="hold"/>
                                        <p:tgtEl>
                                          <p:spTgt spid="5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59</TotalTime>
  <Words>65</Words>
  <Application>Microsoft Macintosh PowerPoint</Application>
  <PresentationFormat>画面に合わせる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北里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藤 直樹</dc:creator>
  <cp:lastModifiedBy>伊藤 直樹</cp:lastModifiedBy>
  <cp:revision>331</cp:revision>
  <cp:lastPrinted>2017-02-08T00:34:03Z</cp:lastPrinted>
  <dcterms:created xsi:type="dcterms:W3CDTF">2015-11-06T08:17:15Z</dcterms:created>
  <dcterms:modified xsi:type="dcterms:W3CDTF">2017-04-03T08:12:44Z</dcterms:modified>
</cp:coreProperties>
</file>